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21.png" ContentType="image/png"/>
  <Override PartName="/ppt/media/image19.png" ContentType="image/png"/>
  <Override PartName="/ppt/media/image1.png" ContentType="image/png"/>
  <Override PartName="/ppt/media/image3.jpeg" ContentType="image/jpeg"/>
  <Override PartName="/ppt/media/image17.png" ContentType="image/png"/>
  <Override PartName="/ppt/media/image4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2.jpeg" ContentType="image/jpeg"/>
  <Override PartName="/ppt/media/image7.jpeg" ContentType="image/jpeg"/>
  <Override PartName="/ppt/media/image18.png" ContentType="image/png"/>
  <Override PartName="/ppt/media/image20.png" ContentType="image/pn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45B68-502C-4380-85BE-024BE6C7C7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6FE90-4A92-44B7-B6FE-7A2D50380B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AE80E-DEC0-4A1F-9C76-B7B16D104E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DF02C-39F2-46A6-8881-275E1F418A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F8E34-F561-4F53-B8D9-74B2A73FA8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CBB85-BAAF-4264-B892-41F316C64B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4ABE4-851C-4706-AFEE-65E09B02B3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4BDCC-9B68-4D96-B379-3966F5E085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F2C1C-027B-4A3F-A8CC-D9B942642A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D8941-CE33-4379-896F-ED42B85F30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F4553-3867-4A25-92B0-B5E856BC6B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B82B7-F410-48BD-9C07-0D75FD56AC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620675A-5029-4D40-BFDB-A9130091687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FEF04C4-F50A-4E6D-925F-F01881E09F4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79360" y="149400"/>
            <a:ext cx="8585280" cy="6470280"/>
            <a:chOff x="279360" y="149400"/>
            <a:chExt cx="8585280" cy="6470280"/>
          </a:xfrm>
        </p:grpSpPr>
        <p:sp>
          <p:nvSpPr>
            <p:cNvPr id="42" name="TextBox 56"/>
            <p:cNvSpPr/>
            <p:nvPr/>
          </p:nvSpPr>
          <p:spPr>
            <a:xfrm>
              <a:off x="351000" y="347760"/>
              <a:ext cx="444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38"/>
            <p:cNvGrpSpPr/>
            <p:nvPr/>
          </p:nvGrpSpPr>
          <p:grpSpPr>
            <a:xfrm>
              <a:off x="575280" y="317520"/>
              <a:ext cx="3604680" cy="3397320"/>
              <a:chOff x="575280" y="317520"/>
              <a:chExt cx="3604680" cy="3397320"/>
            </a:xfrm>
          </p:grpSpPr>
          <p:sp>
            <p:nvSpPr>
              <p:cNvPr id="44" name="Straight Connector 36"/>
              <p:cNvSpPr/>
              <p:nvPr/>
            </p:nvSpPr>
            <p:spPr>
              <a:xfrm>
                <a:off x="1134720" y="3435480"/>
                <a:ext cx="24274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Straight Connector 35"/>
              <p:cNvSpPr/>
              <p:nvPr/>
            </p:nvSpPr>
            <p:spPr>
              <a:xfrm>
                <a:off x="1128600" y="3252960"/>
                <a:ext cx="24274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Straight Connector 34"/>
              <p:cNvSpPr/>
              <p:nvPr/>
            </p:nvSpPr>
            <p:spPr>
              <a:xfrm>
                <a:off x="1128600" y="3076920"/>
                <a:ext cx="24274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Straight Connector 33"/>
              <p:cNvSpPr/>
              <p:nvPr/>
            </p:nvSpPr>
            <p:spPr>
              <a:xfrm>
                <a:off x="1128600" y="2924280"/>
                <a:ext cx="24274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Straight Connector 32"/>
              <p:cNvSpPr/>
              <p:nvPr/>
            </p:nvSpPr>
            <p:spPr>
              <a:xfrm>
                <a:off x="1122120" y="2822760"/>
                <a:ext cx="24274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" name="Group 29"/>
              <p:cNvGrpSpPr/>
              <p:nvPr/>
            </p:nvGrpSpPr>
            <p:grpSpPr>
              <a:xfrm>
                <a:off x="711720" y="317520"/>
                <a:ext cx="3468240" cy="3255120"/>
                <a:chOff x="711720" y="317520"/>
                <a:chExt cx="3468240" cy="3255120"/>
              </a:xfrm>
            </p:grpSpPr>
            <p:grpSp>
              <p:nvGrpSpPr>
                <p:cNvPr id="50" name="Group 16"/>
                <p:cNvGrpSpPr/>
                <p:nvPr/>
              </p:nvGrpSpPr>
              <p:grpSpPr>
                <a:xfrm>
                  <a:off x="1130040" y="497880"/>
                  <a:ext cx="2758320" cy="3074760"/>
                  <a:chOff x="1130040" y="497880"/>
                  <a:chExt cx="2758320" cy="3074760"/>
                </a:xfrm>
              </p:grpSpPr>
              <p:sp>
                <p:nvSpPr>
                  <p:cNvPr id="51" name="Straight Connector 9"/>
                  <p:cNvSpPr/>
                  <p:nvPr/>
                </p:nvSpPr>
                <p:spPr>
                  <a:xfrm>
                    <a:off x="1130040" y="1477800"/>
                    <a:ext cx="242928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Straight Connector 10"/>
                  <p:cNvSpPr/>
                  <p:nvPr/>
                </p:nvSpPr>
                <p:spPr>
                  <a:xfrm>
                    <a:off x="1130040" y="652320"/>
                    <a:ext cx="242928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Straight Connector 12"/>
                  <p:cNvSpPr/>
                  <p:nvPr/>
                </p:nvSpPr>
                <p:spPr>
                  <a:xfrm>
                    <a:off x="1130040" y="912600"/>
                    <a:ext cx="242928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Straight Connector 13"/>
                  <p:cNvSpPr/>
                  <p:nvPr/>
                </p:nvSpPr>
                <p:spPr>
                  <a:xfrm>
                    <a:off x="1130040" y="1103040"/>
                    <a:ext cx="242928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Straight Connector 14"/>
                  <p:cNvSpPr/>
                  <p:nvPr/>
                </p:nvSpPr>
                <p:spPr>
                  <a:xfrm>
                    <a:off x="1130040" y="1311120"/>
                    <a:ext cx="242928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TextBox 15"/>
                  <p:cNvSpPr/>
                  <p:nvPr/>
                </p:nvSpPr>
                <p:spPr>
                  <a:xfrm>
                    <a:off x="3552120" y="497880"/>
                    <a:ext cx="336240" cy="1109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9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Bef>
                        <a:spcPts val="601"/>
                      </a:spcBef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62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49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3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2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TextBox 15"/>
                  <p:cNvSpPr/>
                  <p:nvPr/>
                </p:nvSpPr>
                <p:spPr>
                  <a:xfrm>
                    <a:off x="3552120" y="1575000"/>
                    <a:ext cx="336240" cy="1109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9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Bef>
                        <a:spcPts val="601"/>
                      </a:spcBef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62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49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3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spcAft>
                        <a:spcPts val="201"/>
                      </a:spcAft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2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TextBox 15"/>
                  <p:cNvSpPr/>
                  <p:nvPr/>
                </p:nvSpPr>
                <p:spPr>
                  <a:xfrm>
                    <a:off x="3552120" y="2641680"/>
                    <a:ext cx="336240" cy="930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62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49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3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28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17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9" name="Group 17"/>
                <p:cNvGrpSpPr/>
                <p:nvPr/>
              </p:nvGrpSpPr>
              <p:grpSpPr>
                <a:xfrm>
                  <a:off x="1130040" y="1729800"/>
                  <a:ext cx="2428920" cy="826560"/>
                  <a:chOff x="1130040" y="1729800"/>
                  <a:chExt cx="2428920" cy="826560"/>
                </a:xfrm>
              </p:grpSpPr>
              <p:sp>
                <p:nvSpPr>
                  <p:cNvPr id="60" name="Straight Connector 18"/>
                  <p:cNvSpPr/>
                  <p:nvPr/>
                </p:nvSpPr>
                <p:spPr>
                  <a:xfrm>
                    <a:off x="1130040" y="2554920"/>
                    <a:ext cx="24289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Straight Connector 19"/>
                  <p:cNvSpPr/>
                  <p:nvPr/>
                </p:nvSpPr>
                <p:spPr>
                  <a:xfrm>
                    <a:off x="1130040" y="1729800"/>
                    <a:ext cx="24289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Straight Connector 20"/>
                  <p:cNvSpPr/>
                  <p:nvPr/>
                </p:nvSpPr>
                <p:spPr>
                  <a:xfrm>
                    <a:off x="1130040" y="1990440"/>
                    <a:ext cx="24289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Straight Connector 21"/>
                  <p:cNvSpPr/>
                  <p:nvPr/>
                </p:nvSpPr>
                <p:spPr>
                  <a:xfrm>
                    <a:off x="1130040" y="2181960"/>
                    <a:ext cx="24289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Straight Connector 22"/>
                  <p:cNvSpPr/>
                  <p:nvPr/>
                </p:nvSpPr>
                <p:spPr>
                  <a:xfrm>
                    <a:off x="1130040" y="2388960"/>
                    <a:ext cx="24289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pic>
              <p:nvPicPr>
                <p:cNvPr id="65" name="Picture 4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1220760" y="580680"/>
                  <a:ext cx="2246400" cy="2099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6" name="TextBox 24"/>
                <p:cNvSpPr/>
                <p:nvPr/>
              </p:nvSpPr>
              <p:spPr>
                <a:xfrm>
                  <a:off x="711720" y="1990800"/>
                  <a:ext cx="41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1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TextBox 25"/>
                <p:cNvSpPr/>
                <p:nvPr/>
              </p:nvSpPr>
              <p:spPr>
                <a:xfrm>
                  <a:off x="711720" y="964440"/>
                  <a:ext cx="41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2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TextBox 27"/>
                <p:cNvSpPr/>
                <p:nvPr/>
              </p:nvSpPr>
              <p:spPr>
                <a:xfrm>
                  <a:off x="946080" y="317520"/>
                  <a:ext cx="3233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Top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Bottom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69" name="Picture 30" descr="HCVwt-core_0001.jpg"/>
              <p:cNvPicPr/>
              <p:nvPr/>
            </p:nvPicPr>
            <p:blipFill>
              <a:blip r:embed="rId2"/>
              <a:srcRect l="26275" t="29524" r="26486" b="54895"/>
              <a:stretch/>
            </p:blipFill>
            <p:spPr>
              <a:xfrm flipH="1">
                <a:off x="1220760" y="2721240"/>
                <a:ext cx="2246400" cy="993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TextBox 37"/>
              <p:cNvSpPr/>
              <p:nvPr/>
            </p:nvSpPr>
            <p:spPr>
              <a:xfrm>
                <a:off x="575280" y="307836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re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Group 86"/>
            <p:cNvGrpSpPr/>
            <p:nvPr/>
          </p:nvGrpSpPr>
          <p:grpSpPr>
            <a:xfrm>
              <a:off x="5272200" y="149400"/>
              <a:ext cx="2260440" cy="2489040"/>
              <a:chOff x="5272200" y="149400"/>
              <a:chExt cx="2260440" cy="2489040"/>
            </a:xfrm>
          </p:grpSpPr>
          <p:pic>
            <p:nvPicPr>
              <p:cNvPr id="72" name="Picture 24" descr="E1-SN.jpg"/>
              <p:cNvPicPr/>
              <p:nvPr/>
            </p:nvPicPr>
            <p:blipFill>
              <a:blip r:embed="rId3"/>
              <a:stretch/>
            </p:blipFill>
            <p:spPr>
              <a:xfrm>
                <a:off x="6790680" y="1403280"/>
                <a:ext cx="731880" cy="585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3" name="Picture 25" descr="E2-SN.jpg"/>
              <p:cNvPicPr/>
              <p:nvPr/>
            </p:nvPicPr>
            <p:blipFill>
              <a:blip r:embed="rId4"/>
              <a:stretch/>
            </p:blipFill>
            <p:spPr>
              <a:xfrm>
                <a:off x="6780600" y="785880"/>
                <a:ext cx="731880" cy="585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" name="Picture 29" descr="hsp70.jpg"/>
              <p:cNvPicPr/>
              <p:nvPr/>
            </p:nvPicPr>
            <p:blipFill>
              <a:blip r:embed="rId5"/>
              <a:stretch/>
            </p:blipFill>
            <p:spPr>
              <a:xfrm>
                <a:off x="6800760" y="2042280"/>
                <a:ext cx="731880" cy="585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5" name="TextBox 30"/>
              <p:cNvSpPr/>
              <p:nvPr/>
            </p:nvSpPr>
            <p:spPr>
              <a:xfrm>
                <a:off x="6978240" y="149400"/>
                <a:ext cx="392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Box 31"/>
              <p:cNvSpPr/>
              <p:nvPr/>
            </p:nvSpPr>
            <p:spPr>
              <a:xfrm>
                <a:off x="6058800" y="14940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el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TextBox 32"/>
              <p:cNvSpPr/>
              <p:nvPr/>
            </p:nvSpPr>
            <p:spPr>
              <a:xfrm>
                <a:off x="5619600" y="1573920"/>
                <a:ext cx="372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Box 33"/>
              <p:cNvSpPr/>
              <p:nvPr/>
            </p:nvSpPr>
            <p:spPr>
              <a:xfrm>
                <a:off x="5619600" y="999360"/>
                <a:ext cx="372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Box 35"/>
              <p:cNvSpPr/>
              <p:nvPr/>
            </p:nvSpPr>
            <p:spPr>
              <a:xfrm>
                <a:off x="5272200" y="2207880"/>
                <a:ext cx="720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Hsp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Box 36"/>
              <p:cNvSpPr/>
              <p:nvPr/>
            </p:nvSpPr>
            <p:spPr>
              <a:xfrm>
                <a:off x="5390280" y="505440"/>
                <a:ext cx="54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BFA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Box 37"/>
              <p:cNvSpPr/>
              <p:nvPr/>
            </p:nvSpPr>
            <p:spPr>
              <a:xfrm>
                <a:off x="5999400" y="505440"/>
                <a:ext cx="703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        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Box 38"/>
              <p:cNvSpPr/>
              <p:nvPr/>
            </p:nvSpPr>
            <p:spPr>
              <a:xfrm>
                <a:off x="6789600" y="474840"/>
                <a:ext cx="66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      +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3" name="Picture 41" descr="E1-lysate.jpg"/>
              <p:cNvPicPr/>
              <p:nvPr/>
            </p:nvPicPr>
            <p:blipFill>
              <a:blip r:embed="rId6"/>
              <a:stretch/>
            </p:blipFill>
            <p:spPr>
              <a:xfrm>
                <a:off x="5992560" y="1423800"/>
                <a:ext cx="745200" cy="585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4" name="Picture 42" descr="E2-lysate.jpg"/>
              <p:cNvPicPr/>
              <p:nvPr/>
            </p:nvPicPr>
            <p:blipFill>
              <a:blip r:embed="rId7"/>
              <a:stretch/>
            </p:blipFill>
            <p:spPr>
              <a:xfrm>
                <a:off x="5988960" y="785880"/>
                <a:ext cx="738360" cy="585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Picture 20" descr="bfa-hsp70lysate.jpg"/>
              <p:cNvPicPr/>
              <p:nvPr/>
            </p:nvPicPr>
            <p:blipFill>
              <a:blip r:embed="rId8"/>
              <a:stretch/>
            </p:blipFill>
            <p:spPr>
              <a:xfrm>
                <a:off x="5983920" y="2062440"/>
                <a:ext cx="754560" cy="57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Right Brace 21"/>
              <p:cNvSpPr/>
              <p:nvPr/>
            </p:nvSpPr>
            <p:spPr>
              <a:xfrm rot="16200000">
                <a:off x="6264360" y="173880"/>
                <a:ext cx="144720" cy="652680"/>
              </a:xfrm>
              <a:custGeom>
                <a:avLst/>
                <a:gdLst>
                  <a:gd name="textAreaLeft" fmla="*/ 0 w 144720"/>
                  <a:gd name="textAreaRight" fmla="*/ 52200 w 144720"/>
                  <a:gd name="textAreaTop" fmla="*/ 3600 h 652680"/>
                  <a:gd name="textAreaBottom" fmla="*/ 649080 h 652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00"/>
                      <a:pt x="10800" y="400"/>
                    </a:cubicBezTo>
                    <a:lnTo>
                      <a:pt x="10800" y="10400"/>
                    </a:lnTo>
                    <a:cubicBezTo>
                      <a:pt x="10800" y="10600"/>
                      <a:pt x="16200" y="10800"/>
                      <a:pt x="21600" y="10800"/>
                    </a:cubicBezTo>
                    <a:cubicBezTo>
                      <a:pt x="16200" y="10800"/>
                      <a:pt x="10800" y="11000"/>
                      <a:pt x="10800" y="11200"/>
                    </a:cubicBezTo>
                    <a:lnTo>
                      <a:pt x="10800" y="21200"/>
                    </a:lnTo>
                    <a:cubicBezTo>
                      <a:pt x="10800" y="21400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ight Brace 21"/>
              <p:cNvSpPr/>
              <p:nvPr/>
            </p:nvSpPr>
            <p:spPr>
              <a:xfrm rot="16200000">
                <a:off x="7111440" y="182520"/>
                <a:ext cx="144720" cy="652680"/>
              </a:xfrm>
              <a:custGeom>
                <a:avLst/>
                <a:gdLst>
                  <a:gd name="textAreaLeft" fmla="*/ 0 w 144720"/>
                  <a:gd name="textAreaRight" fmla="*/ 52200 w 144720"/>
                  <a:gd name="textAreaTop" fmla="*/ 3600 h 652680"/>
                  <a:gd name="textAreaBottom" fmla="*/ 649080 h 652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00"/>
                      <a:pt x="10800" y="400"/>
                    </a:cubicBezTo>
                    <a:lnTo>
                      <a:pt x="10800" y="10400"/>
                    </a:lnTo>
                    <a:cubicBezTo>
                      <a:pt x="10800" y="10600"/>
                      <a:pt x="16200" y="10800"/>
                      <a:pt x="21600" y="10800"/>
                    </a:cubicBezTo>
                    <a:cubicBezTo>
                      <a:pt x="16200" y="10800"/>
                      <a:pt x="10800" y="11000"/>
                      <a:pt x="10800" y="11200"/>
                    </a:cubicBezTo>
                    <a:lnTo>
                      <a:pt x="10800" y="21200"/>
                    </a:lnTo>
                    <a:cubicBezTo>
                      <a:pt x="10800" y="21400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Text Box 36"/>
            <p:cNvSpPr/>
            <p:nvPr/>
          </p:nvSpPr>
          <p:spPr>
            <a:xfrm>
              <a:off x="4371120" y="31752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Group 28"/>
            <p:cNvGrpSpPr/>
            <p:nvPr/>
          </p:nvGrpSpPr>
          <p:grpSpPr>
            <a:xfrm>
              <a:off x="4388400" y="2751120"/>
              <a:ext cx="4441680" cy="2265480"/>
              <a:chOff x="4388400" y="2751120"/>
              <a:chExt cx="4441680" cy="2265480"/>
            </a:xfrm>
          </p:grpSpPr>
          <p:sp>
            <p:nvSpPr>
              <p:cNvPr id="90" name="TextBox 8"/>
              <p:cNvSpPr/>
              <p:nvPr/>
            </p:nvSpPr>
            <p:spPr>
              <a:xfrm>
                <a:off x="5588280" y="3011760"/>
                <a:ext cx="855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BHK-WNV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9"/>
              <p:cNvSpPr/>
              <p:nvPr/>
            </p:nvSpPr>
            <p:spPr>
              <a:xfrm>
                <a:off x="7325280" y="3011760"/>
                <a:ext cx="855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BHK-WNV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Box 10"/>
              <p:cNvSpPr/>
              <p:nvPr/>
            </p:nvSpPr>
            <p:spPr>
              <a:xfrm>
                <a:off x="8152560" y="3309840"/>
                <a:ext cx="6775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Endo-H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Box 12"/>
              <p:cNvSpPr/>
              <p:nvPr/>
            </p:nvSpPr>
            <p:spPr>
              <a:xfrm>
                <a:off x="5771160" y="3297240"/>
                <a:ext cx="53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     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Box 62"/>
              <p:cNvSpPr/>
              <p:nvPr/>
            </p:nvSpPr>
            <p:spPr>
              <a:xfrm>
                <a:off x="7519680" y="3296880"/>
                <a:ext cx="489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    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Box 63"/>
              <p:cNvSpPr/>
              <p:nvPr/>
            </p:nvSpPr>
            <p:spPr>
              <a:xfrm>
                <a:off x="8202960" y="3771360"/>
                <a:ext cx="36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Box 64"/>
              <p:cNvSpPr/>
              <p:nvPr/>
            </p:nvSpPr>
            <p:spPr>
              <a:xfrm>
                <a:off x="8202960" y="4584600"/>
                <a:ext cx="36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Box 6"/>
              <p:cNvSpPr/>
              <p:nvPr/>
            </p:nvSpPr>
            <p:spPr>
              <a:xfrm>
                <a:off x="4882680" y="3011760"/>
                <a:ext cx="522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BHK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Box 11"/>
              <p:cNvSpPr/>
              <p:nvPr/>
            </p:nvSpPr>
            <p:spPr>
              <a:xfrm>
                <a:off x="4833720" y="3297240"/>
                <a:ext cx="61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      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ight Brace 17"/>
              <p:cNvSpPr/>
              <p:nvPr/>
            </p:nvSpPr>
            <p:spPr>
              <a:xfrm rot="16200000">
                <a:off x="5081760" y="3073680"/>
                <a:ext cx="126720" cy="565920"/>
              </a:xfrm>
              <a:custGeom>
                <a:avLst/>
                <a:gdLst>
                  <a:gd name="textAreaLeft" fmla="*/ 0 w 126720"/>
                  <a:gd name="textAreaRight" fmla="*/ 45720 w 126720"/>
                  <a:gd name="textAreaTop" fmla="*/ 3240 h 565920"/>
                  <a:gd name="textAreaBottom" fmla="*/ 562680 h 565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03"/>
                      <a:pt x="10800" y="406"/>
                    </a:cubicBezTo>
                    <a:lnTo>
                      <a:pt x="10800" y="10394"/>
                    </a:lnTo>
                    <a:cubicBezTo>
                      <a:pt x="10800" y="10597"/>
                      <a:pt x="16200" y="10800"/>
                      <a:pt x="21600" y="10800"/>
                    </a:cubicBezTo>
                    <a:cubicBezTo>
                      <a:pt x="16200" y="10800"/>
                      <a:pt x="10800" y="11003"/>
                      <a:pt x="10800" y="11206"/>
                    </a:cubicBezTo>
                    <a:lnTo>
                      <a:pt x="10800" y="21194"/>
                    </a:lnTo>
                    <a:cubicBezTo>
                      <a:pt x="10800" y="21397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ight Brace 18"/>
              <p:cNvSpPr/>
              <p:nvPr/>
            </p:nvSpPr>
            <p:spPr>
              <a:xfrm rot="16200000">
                <a:off x="5939640" y="3073320"/>
                <a:ext cx="126720" cy="566640"/>
              </a:xfrm>
              <a:custGeom>
                <a:avLst/>
                <a:gdLst>
                  <a:gd name="textAreaLeft" fmla="*/ 0 w 126720"/>
                  <a:gd name="textAreaRight" fmla="*/ 45720 w 126720"/>
                  <a:gd name="textAreaTop" fmla="*/ 3240 h 566640"/>
                  <a:gd name="textAreaBottom" fmla="*/ 563400 h 566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03"/>
                      <a:pt x="10800" y="406"/>
                    </a:cubicBezTo>
                    <a:lnTo>
                      <a:pt x="10800" y="10394"/>
                    </a:lnTo>
                    <a:cubicBezTo>
                      <a:pt x="10800" y="10597"/>
                      <a:pt x="16200" y="10800"/>
                      <a:pt x="21600" y="10800"/>
                    </a:cubicBezTo>
                    <a:cubicBezTo>
                      <a:pt x="16200" y="10800"/>
                      <a:pt x="10800" y="11003"/>
                      <a:pt x="10800" y="11206"/>
                    </a:cubicBezTo>
                    <a:lnTo>
                      <a:pt x="10800" y="21194"/>
                    </a:lnTo>
                    <a:cubicBezTo>
                      <a:pt x="10800" y="21397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Box 7"/>
              <p:cNvSpPr/>
              <p:nvPr/>
            </p:nvSpPr>
            <p:spPr>
              <a:xfrm>
                <a:off x="6742080" y="3011760"/>
                <a:ext cx="537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BHK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Box 13"/>
              <p:cNvSpPr/>
              <p:nvPr/>
            </p:nvSpPr>
            <p:spPr>
              <a:xfrm>
                <a:off x="6713640" y="3296880"/>
                <a:ext cx="57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     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ight Brace 19"/>
              <p:cNvSpPr/>
              <p:nvPr/>
            </p:nvSpPr>
            <p:spPr>
              <a:xfrm rot="16200000">
                <a:off x="6944400" y="3072600"/>
                <a:ext cx="128520" cy="565920"/>
              </a:xfrm>
              <a:custGeom>
                <a:avLst/>
                <a:gdLst>
                  <a:gd name="textAreaLeft" fmla="*/ 0 w 128520"/>
                  <a:gd name="textAreaRight" fmla="*/ 46440 w 128520"/>
                  <a:gd name="textAreaTop" fmla="*/ 3240 h 565920"/>
                  <a:gd name="textAreaBottom" fmla="*/ 562680 h 565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03"/>
                      <a:pt x="10800" y="406"/>
                    </a:cubicBezTo>
                    <a:lnTo>
                      <a:pt x="10800" y="10394"/>
                    </a:lnTo>
                    <a:cubicBezTo>
                      <a:pt x="10800" y="10597"/>
                      <a:pt x="16200" y="10800"/>
                      <a:pt x="21600" y="10800"/>
                    </a:cubicBezTo>
                    <a:cubicBezTo>
                      <a:pt x="16200" y="10800"/>
                      <a:pt x="10800" y="11003"/>
                      <a:pt x="10800" y="11206"/>
                    </a:cubicBezTo>
                    <a:lnTo>
                      <a:pt x="10800" y="21194"/>
                    </a:lnTo>
                    <a:cubicBezTo>
                      <a:pt x="10800" y="21397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ight Brace 20"/>
              <p:cNvSpPr/>
              <p:nvPr/>
            </p:nvSpPr>
            <p:spPr>
              <a:xfrm rot="16200000">
                <a:off x="7689600" y="3073320"/>
                <a:ext cx="126720" cy="566640"/>
              </a:xfrm>
              <a:custGeom>
                <a:avLst/>
                <a:gdLst>
                  <a:gd name="textAreaLeft" fmla="*/ 0 w 126720"/>
                  <a:gd name="textAreaRight" fmla="*/ 45720 w 126720"/>
                  <a:gd name="textAreaTop" fmla="*/ 3240 h 566640"/>
                  <a:gd name="textAreaBottom" fmla="*/ 563400 h 566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03"/>
                      <a:pt x="10800" y="406"/>
                    </a:cubicBezTo>
                    <a:lnTo>
                      <a:pt x="10800" y="10394"/>
                    </a:lnTo>
                    <a:cubicBezTo>
                      <a:pt x="10800" y="10597"/>
                      <a:pt x="16200" y="10800"/>
                      <a:pt x="21600" y="10800"/>
                    </a:cubicBezTo>
                    <a:cubicBezTo>
                      <a:pt x="16200" y="10800"/>
                      <a:pt x="10800" y="11003"/>
                      <a:pt x="10800" y="11206"/>
                    </a:cubicBezTo>
                    <a:lnTo>
                      <a:pt x="10800" y="21194"/>
                    </a:lnTo>
                    <a:cubicBezTo>
                      <a:pt x="10800" y="21397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Box 21"/>
              <p:cNvSpPr/>
              <p:nvPr/>
            </p:nvSpPr>
            <p:spPr>
              <a:xfrm>
                <a:off x="5298840" y="275112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el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22"/>
              <p:cNvSpPr/>
              <p:nvPr/>
            </p:nvSpPr>
            <p:spPr>
              <a:xfrm>
                <a:off x="7175520" y="2751120"/>
                <a:ext cx="392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07" name="Picture 46" descr="endoH_e2-sn-wn.jpg"/>
              <p:cNvPicPr/>
              <p:nvPr/>
            </p:nvPicPr>
            <p:blipFill>
              <a:blip r:embed="rId9"/>
              <a:srcRect l="1214" t="15664" r="0" b="1153"/>
              <a:stretch/>
            </p:blipFill>
            <p:spPr>
              <a:xfrm>
                <a:off x="7427880" y="3593880"/>
                <a:ext cx="650160" cy="639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8" name="Picture 47" descr="endoH_e1-wn-sn.jpg"/>
              <p:cNvPicPr/>
              <p:nvPr/>
            </p:nvPicPr>
            <p:blipFill>
              <a:blip r:embed="rId10"/>
              <a:srcRect l="0" t="7593" r="0" b="2109"/>
              <a:stretch/>
            </p:blipFill>
            <p:spPr>
              <a:xfrm>
                <a:off x="7431120" y="4309200"/>
                <a:ext cx="658080" cy="693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Picture 44" descr="bhk-e1-sn.jpg"/>
              <p:cNvPicPr/>
              <p:nvPr/>
            </p:nvPicPr>
            <p:blipFill>
              <a:blip r:embed="rId11"/>
              <a:srcRect l="0" t="0" r="0" b="7940"/>
              <a:stretch/>
            </p:blipFill>
            <p:spPr>
              <a:xfrm>
                <a:off x="6681240" y="4309560"/>
                <a:ext cx="636840" cy="70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0" name="TextBox 15"/>
              <p:cNvSpPr/>
              <p:nvPr/>
            </p:nvSpPr>
            <p:spPr>
              <a:xfrm>
                <a:off x="4388400" y="3771360"/>
                <a:ext cx="36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TextBox 16"/>
              <p:cNvSpPr/>
              <p:nvPr/>
            </p:nvSpPr>
            <p:spPr>
              <a:xfrm>
                <a:off x="4388400" y="4457520"/>
                <a:ext cx="36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2" name="Picture 51" descr="e1-endoH-lys-WN.jpg"/>
              <p:cNvPicPr/>
              <p:nvPr/>
            </p:nvPicPr>
            <p:blipFill>
              <a:blip r:embed="rId12"/>
              <a:srcRect l="0" t="0" r="0" b="7251"/>
              <a:stretch/>
            </p:blipFill>
            <p:spPr>
              <a:xfrm>
                <a:off x="5647320" y="4303440"/>
                <a:ext cx="703800" cy="712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Picture 52" descr="e1-endoH-bhk-lys.jpg"/>
              <p:cNvPicPr/>
              <p:nvPr/>
            </p:nvPicPr>
            <p:blipFill>
              <a:blip r:embed="rId13"/>
              <a:srcRect l="0" t="7415" r="0" b="0"/>
              <a:stretch/>
            </p:blipFill>
            <p:spPr>
              <a:xfrm>
                <a:off x="4784400" y="4304880"/>
                <a:ext cx="703800" cy="711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4" name="Picture 53" descr="e2-wn-endoH-lys.jpg"/>
              <p:cNvPicPr/>
              <p:nvPr/>
            </p:nvPicPr>
            <p:blipFill>
              <a:blip r:embed="rId14"/>
              <a:srcRect l="0" t="0" r="0" b="15125"/>
              <a:stretch/>
            </p:blipFill>
            <p:spPr>
              <a:xfrm>
                <a:off x="5647320" y="3593880"/>
                <a:ext cx="703800" cy="651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Picture 54" descr="e2-bhk-endoHlysate.jpg"/>
              <p:cNvPicPr/>
              <p:nvPr/>
            </p:nvPicPr>
            <p:blipFill>
              <a:blip r:embed="rId15"/>
              <a:srcRect l="0" t="4364" r="0" b="10794"/>
              <a:stretch/>
            </p:blipFill>
            <p:spPr>
              <a:xfrm>
                <a:off x="4784400" y="3593880"/>
                <a:ext cx="703800" cy="651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Picture 55" descr="e2-endoH-bhk-sn.jpg"/>
              <p:cNvPicPr/>
              <p:nvPr/>
            </p:nvPicPr>
            <p:blipFill>
              <a:blip r:embed="rId16"/>
              <a:srcRect l="0" t="16995" r="0" b="197"/>
              <a:stretch/>
            </p:blipFill>
            <p:spPr>
              <a:xfrm>
                <a:off x="6676920" y="3593880"/>
                <a:ext cx="641160" cy="6541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17" name="Text Box 36"/>
            <p:cNvSpPr/>
            <p:nvPr/>
          </p:nvSpPr>
          <p:spPr>
            <a:xfrm>
              <a:off x="4371120" y="269568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87"/>
            <p:cNvSpPr/>
            <p:nvPr/>
          </p:nvSpPr>
          <p:spPr>
            <a:xfrm>
              <a:off x="279360" y="5065560"/>
              <a:ext cx="858528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spcAft>
                  <a:spcPts val="4201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3. (A) Detection of C, E1 and E2 proteins of HCVbp in a sucrose gradient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CVbp released by BHK-WNV cells were analyzed on a 20-60% sucrose gradient. Fractions were harvested manually from the top and analyzed by WB for detection of HCV structural proteins (upper panels)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r hsp70 (lower panels).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B) Effects of brefeldin A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BFA) on HCV release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welve hours after transfection of BHK-WNV cells with pHCVp7, cells were treated with 20 µM BFA for 24 h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d the amounts of HCV E1 and E2 proteins as well as those of Hsp70 in cell lysates and released particles were analyzed by WB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C) Requirement of viral glycoproteins maturation for HCV release.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BHK and BHK-WNV cells were transfected with pHCVp7 and 3 days later, cells and particles in the pelleted SN were harvested and treated with endo-H, followed by WB analysis. *, 30 ml culture media was used for parental BHK cells (15 ml for BHK-WNV cells)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9" name="Group 90"/>
            <p:cNvGrpSpPr/>
            <p:nvPr/>
          </p:nvGrpSpPr>
          <p:grpSpPr>
            <a:xfrm>
              <a:off x="365040" y="3971880"/>
              <a:ext cx="3554640" cy="939960"/>
              <a:chOff x="365040" y="3971880"/>
              <a:chExt cx="3554640" cy="939960"/>
            </a:xfrm>
          </p:grpSpPr>
          <p:pic>
            <p:nvPicPr>
              <p:cNvPr id="120" name="Picture 91" descr=""/>
              <p:cNvPicPr/>
              <p:nvPr/>
            </p:nvPicPr>
            <p:blipFill>
              <a:blip r:embed="rId17"/>
              <a:stretch/>
            </p:blipFill>
            <p:spPr>
              <a:xfrm>
                <a:off x="1197360" y="4501800"/>
                <a:ext cx="2331360" cy="41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1" name="Picture 92" descr=""/>
              <p:cNvPicPr/>
              <p:nvPr/>
            </p:nvPicPr>
            <p:blipFill>
              <a:blip r:embed="rId18"/>
              <a:srcRect l="0" t="0" r="1176" b="18907"/>
              <a:stretch/>
            </p:blipFill>
            <p:spPr>
              <a:xfrm>
                <a:off x="1197360" y="4267800"/>
                <a:ext cx="2323440" cy="158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2" name="TextBox 93"/>
              <p:cNvSpPr/>
              <p:nvPr/>
            </p:nvSpPr>
            <p:spPr>
              <a:xfrm>
                <a:off x="943920" y="3971880"/>
                <a:ext cx="2975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Top</a:t>
                </a: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            Bottom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Box 94"/>
              <p:cNvSpPr/>
              <p:nvPr/>
            </p:nvSpPr>
            <p:spPr>
              <a:xfrm>
                <a:off x="365040" y="4214880"/>
                <a:ext cx="833400" cy="59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Aft>
                    <a:spcPts val="1199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Hsp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spcAft>
                    <a:spcPts val="1800"/>
                  </a:spcAft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E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Box 39"/>
          <p:cNvSpPr/>
          <p:nvPr/>
        </p:nvSpPr>
        <p:spPr>
          <a:xfrm rot="18669000">
            <a:off x="5958000" y="4756320"/>
            <a:ext cx="97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FN + MP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40"/>
          <p:cNvSpPr/>
          <p:nvPr/>
        </p:nvSpPr>
        <p:spPr>
          <a:xfrm rot="18669000">
            <a:off x="6554520" y="475380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FN + Rib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"/>
          <p:cNvGrpSpPr/>
          <p:nvPr/>
        </p:nvGrpSpPr>
        <p:grpSpPr>
          <a:xfrm>
            <a:off x="195120" y="114480"/>
            <a:ext cx="8771040" cy="6667200"/>
            <a:chOff x="195120" y="114480"/>
            <a:chExt cx="8771040" cy="6667200"/>
          </a:xfrm>
        </p:grpSpPr>
        <p:pic>
          <p:nvPicPr>
            <p:cNvPr id="127" name="Chart 62" descr=""/>
            <p:cNvPicPr/>
            <p:nvPr/>
          </p:nvPicPr>
          <p:blipFill>
            <a:blip r:embed="rId1"/>
            <a:stretch/>
          </p:blipFill>
          <p:spPr>
            <a:xfrm>
              <a:off x="1352520" y="2706840"/>
              <a:ext cx="2890800" cy="265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8" name="Rectangle 39"/>
            <p:cNvSpPr/>
            <p:nvPr/>
          </p:nvSpPr>
          <p:spPr>
            <a:xfrm>
              <a:off x="195120" y="5227560"/>
              <a:ext cx="877104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spcAft>
                  <a:spcPts val="601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3. (D) No encapsidation of WNV SG-rep into infectious HCVbp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HK-WNV cells were transfected with either p684-SG(L+I)-HDV (HCV), pIRES1hyg-WNV encoding WNV structural genes (WNV) or mock plasmid (Media). SN were harvested 3 days later; pellets were resuspended in complete medium, serially diluted and incubated with Huh-7.5 cells for 2 hr; cells were cultured for another 48 hr and RNL activity was measured in cell lysates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E) Effects of antiviral treatment against WNV SG-replicon on HCV production and release by BHK-WNV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left) BHK-WNV cells were treated with either IFN, IFN + MPA, or IFN + Ribavirin for 10 days, then RNL activity (indicator of WNV SG replication) was measured. (right) Control and antiviral-treated BHK-WNV cells were transfected with plasmid encoding HCVbp. Three days later, E1 content in cell lysates and pelleted supernatants were determined by WB; RNL was used to confirm the WNV SG-rep inhibition by antivirals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9" name=""/>
            <p:cNvGrpSpPr/>
            <p:nvPr/>
          </p:nvGrpSpPr>
          <p:grpSpPr>
            <a:xfrm>
              <a:off x="597600" y="114480"/>
              <a:ext cx="7740720" cy="5128560"/>
              <a:chOff x="597600" y="114480"/>
              <a:chExt cx="7740720" cy="5128560"/>
            </a:xfrm>
          </p:grpSpPr>
          <p:sp>
            <p:nvSpPr>
              <p:cNvPr id="130" name="Text Box 36"/>
              <p:cNvSpPr/>
              <p:nvPr/>
            </p:nvSpPr>
            <p:spPr>
              <a:xfrm>
                <a:off x="605160" y="2600280"/>
                <a:ext cx="3499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TextBox 37"/>
              <p:cNvSpPr/>
              <p:nvPr/>
            </p:nvSpPr>
            <p:spPr>
              <a:xfrm rot="18669000">
                <a:off x="4913280" y="4700520"/>
                <a:ext cx="831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TextBox 38"/>
              <p:cNvSpPr/>
              <p:nvPr/>
            </p:nvSpPr>
            <p:spPr>
              <a:xfrm rot="18669000">
                <a:off x="5786280" y="4566960"/>
                <a:ext cx="473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IF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Box 31"/>
              <p:cNvSpPr/>
              <p:nvPr/>
            </p:nvSpPr>
            <p:spPr>
              <a:xfrm>
                <a:off x="7791840" y="364644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ell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TextBox 32"/>
              <p:cNvSpPr/>
              <p:nvPr/>
            </p:nvSpPr>
            <p:spPr>
              <a:xfrm>
                <a:off x="7792920" y="2589120"/>
                <a:ext cx="392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5" name="Group 24"/>
              <p:cNvGrpSpPr/>
              <p:nvPr/>
            </p:nvGrpSpPr>
            <p:grpSpPr>
              <a:xfrm>
                <a:off x="4780800" y="2575080"/>
                <a:ext cx="496080" cy="1717200"/>
                <a:chOff x="4780800" y="2575080"/>
                <a:chExt cx="496080" cy="1717200"/>
              </a:xfrm>
            </p:grpSpPr>
            <p:sp>
              <p:nvSpPr>
                <p:cNvPr id="136" name="TextBox 33"/>
                <p:cNvSpPr/>
                <p:nvPr/>
              </p:nvSpPr>
              <p:spPr>
                <a:xfrm>
                  <a:off x="4846320" y="3309840"/>
                  <a:ext cx="430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TextBox 34"/>
                <p:cNvSpPr/>
                <p:nvPr/>
              </p:nvSpPr>
              <p:spPr>
                <a:xfrm>
                  <a:off x="4907520" y="2575080"/>
                  <a:ext cx="3682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TextBox 35"/>
                <p:cNvSpPr/>
                <p:nvPr/>
              </p:nvSpPr>
              <p:spPr>
                <a:xfrm>
                  <a:off x="4780800" y="4015800"/>
                  <a:ext cx="493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RNL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9" name="Left Brace 20"/>
              <p:cNvSpPr/>
              <p:nvPr/>
            </p:nvSpPr>
            <p:spPr>
              <a:xfrm flipH="1">
                <a:off x="7658280" y="3130560"/>
                <a:ext cx="155520" cy="1349280"/>
              </a:xfrm>
              <a:custGeom>
                <a:avLst/>
                <a:gdLst>
                  <a:gd name="textAreaLeft" fmla="*/ 99360 w 155520"/>
                  <a:gd name="textAreaRight" fmla="*/ 155520 w 155520"/>
                  <a:gd name="textAreaTop" fmla="*/ 16560 h 1349280"/>
                  <a:gd name="textAreaBottom" fmla="*/ 1332720 h 1349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429"/>
                      <a:pt x="10800" y="858"/>
                    </a:cubicBezTo>
                    <a:lnTo>
                      <a:pt x="10800" y="9942"/>
                    </a:lnTo>
                    <a:cubicBezTo>
                      <a:pt x="10800" y="10371"/>
                      <a:pt x="5400" y="10800"/>
                      <a:pt x="0" y="10800"/>
                    </a:cubicBezTo>
                    <a:cubicBezTo>
                      <a:pt x="5400" y="10800"/>
                      <a:pt x="10800" y="11229"/>
                      <a:pt x="10800" y="11658"/>
                    </a:cubicBezTo>
                    <a:lnTo>
                      <a:pt x="10800" y="20742"/>
                    </a:lnTo>
                    <a:cubicBezTo>
                      <a:pt x="10800" y="21171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40" name="Picture 19" descr=""/>
              <p:cNvPicPr/>
              <p:nvPr/>
            </p:nvPicPr>
            <p:blipFill>
              <a:blip r:embed="rId2"/>
              <a:stretch/>
            </p:blipFill>
            <p:spPr>
              <a:xfrm>
                <a:off x="5278320" y="2422440"/>
                <a:ext cx="2367000" cy="2057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1" name="Text Box 15"/>
              <p:cNvSpPr/>
              <p:nvPr/>
            </p:nvSpPr>
            <p:spPr>
              <a:xfrm rot="16200000">
                <a:off x="367920" y="3591720"/>
                <a:ext cx="1845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RNL (RLU/25,000 cells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2" name="Group 11"/>
              <p:cNvGrpSpPr/>
              <p:nvPr/>
            </p:nvGrpSpPr>
            <p:grpSpPr>
              <a:xfrm>
                <a:off x="1027080" y="114480"/>
                <a:ext cx="3268800" cy="2551320"/>
                <a:chOff x="1027080" y="114480"/>
                <a:chExt cx="3268800" cy="2551320"/>
              </a:xfrm>
            </p:grpSpPr>
            <p:pic>
              <p:nvPicPr>
                <p:cNvPr id="143" name="Chart 27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027080" y="114480"/>
                  <a:ext cx="3268800" cy="247680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144" name="Group 10"/>
                <p:cNvGrpSpPr/>
                <p:nvPr/>
              </p:nvGrpSpPr>
              <p:grpSpPr>
                <a:xfrm>
                  <a:off x="1172880" y="151920"/>
                  <a:ext cx="269280" cy="2116080"/>
                  <a:chOff x="1172880" y="151920"/>
                  <a:chExt cx="269280" cy="2116080"/>
                </a:xfrm>
              </p:grpSpPr>
              <p:sp>
                <p:nvSpPr>
                  <p:cNvPr id="145" name="Rectangle 9"/>
                  <p:cNvSpPr/>
                  <p:nvPr/>
                </p:nvSpPr>
                <p:spPr>
                  <a:xfrm>
                    <a:off x="1172880" y="208440"/>
                    <a:ext cx="269280" cy="201888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TextBox 13"/>
                  <p:cNvSpPr/>
                  <p:nvPr/>
                </p:nvSpPr>
                <p:spPr>
                  <a:xfrm rot="16200000">
                    <a:off x="245520" y="1079280"/>
                    <a:ext cx="21160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RNL activity (RLU/target cell)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7" name="TextBox 4"/>
                <p:cNvSpPr/>
                <p:nvPr/>
              </p:nvSpPr>
              <p:spPr>
                <a:xfrm>
                  <a:off x="2167560" y="2404440"/>
                  <a:ext cx="1873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Relative virus inoculums 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8" name="Text Box 36"/>
              <p:cNvSpPr/>
              <p:nvPr/>
            </p:nvSpPr>
            <p:spPr>
              <a:xfrm>
                <a:off x="597600" y="114480"/>
                <a:ext cx="36504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07:00:19Z</dcterms:created>
  <dc:creator>bertrand saunier</dc:creator>
  <dc:description/>
  <dc:language>en-US</dc:language>
  <cp:lastModifiedBy>triyatnm</cp:lastModifiedBy>
  <dcterms:modified xsi:type="dcterms:W3CDTF">2011-03-09T18:24:00Z</dcterms:modified>
  <cp:revision>140</cp:revision>
  <dc:subject/>
  <dc:title>Slide 1</dc:title>
</cp:coreProperties>
</file>